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959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3933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83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545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270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92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08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7877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72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453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00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502918" y="353811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6018414" y="353811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10" name="Image 9" descr="C:\Users\ledorma191\Documents\THESE\WP2\ACP\MRS 15°C\Global MRS15 Individus.tif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5863" y="242811"/>
            <a:ext cx="5303519" cy="56039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Image 10" descr="C:\Users\ledorma191\Documents\THESE\WP2\ACP\MRS 15°C\Fichier OK\MRS15 GLOBAL.ti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143" y="538477"/>
            <a:ext cx="5180503" cy="501257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338742" y="5640326"/>
            <a:ext cx="11359344" cy="10143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US" sz="14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Principal Component Analysis of the studied compounds (black arrows) with illustrative variables representing the four strains of the model (red arrows). (B) Distribution of the samples in condition C (control), 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out phages) and P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phages) for all times at 15°C. Samples are named as follows: Condition (C: control, D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out phages, P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phages). Time point (0, 48h, 72h, 96h, 168h). Biological replicate (1, 2, 3) (e.g. C144_1 means Control at 144h, biological replicate 1). </a:t>
            </a:r>
            <a:endParaRPr lang="fr-FR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888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4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8</cp:revision>
  <dcterms:created xsi:type="dcterms:W3CDTF">2022-07-22T12:25:17Z</dcterms:created>
  <dcterms:modified xsi:type="dcterms:W3CDTF">2022-10-10T14:15:58Z</dcterms:modified>
</cp:coreProperties>
</file>